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8" r:id="rId2"/>
  </p:sldIdLst>
  <p:sldSz cx="12192000" cy="6858000"/>
  <p:notesSz cx="6858000" cy="9947275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81" d="100"/>
          <a:sy n="81" d="100"/>
        </p:scale>
        <p:origin x="-102" y="-66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99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99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B0CB566-3B20-4154-A778-75285434B7EA}" type="datetimeFigureOut">
              <a:rPr lang="zh-CN" altLang="en-US" smtClean="0"/>
              <a:pPr/>
              <a:t>2018/10/27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444500" y="1243013"/>
            <a:ext cx="5969000" cy="33575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787126"/>
            <a:ext cx="5486400" cy="391674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9448185"/>
            <a:ext cx="2971800" cy="499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9448185"/>
            <a:ext cx="2971800" cy="499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E726D09-22FA-4882-9C88-E540C433E568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2650077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F8CA6-399B-4918-8F4B-292564F58E24}" type="datetimeFigureOut">
              <a:rPr lang="zh-CN" altLang="en-US" smtClean="0"/>
              <a:pPr/>
              <a:t>2018/10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CFC837-AA7B-4BD9-9181-650E0389EF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1878518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F8CA6-399B-4918-8F4B-292564F58E24}" type="datetimeFigureOut">
              <a:rPr lang="zh-CN" altLang="en-US" smtClean="0"/>
              <a:pPr/>
              <a:t>2018/10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CFC837-AA7B-4BD9-9181-650E0389EF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7116594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F8CA6-399B-4918-8F4B-292564F58E24}" type="datetimeFigureOut">
              <a:rPr lang="zh-CN" altLang="en-US" smtClean="0"/>
              <a:pPr/>
              <a:t>2018/10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CFC837-AA7B-4BD9-9181-650E0389EF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319000906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内容占位符 1"/>
          <p:cNvSpPr>
            <a:spLocks noGrp="1"/>
          </p:cNvSpPr>
          <p:nvPr>
            <p:ph/>
          </p:nvPr>
        </p:nvSpPr>
        <p:spPr>
          <a:xfrm>
            <a:off x="609600" y="274639"/>
            <a:ext cx="10972800" cy="585152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3" name="Rectangle 4">
            <a:extLst>
              <a:ext uri="{FF2B5EF4-FFF2-40B4-BE49-F238E27FC236}">
                <a16:creationId xmlns:a16="http://schemas.microsoft.com/office/drawing/2014/main" xmlns="" id="{D07C8E89-CA08-4FDD-8243-ECECF9EF71BB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4" name="Rectangle 5">
            <a:extLst>
              <a:ext uri="{FF2B5EF4-FFF2-40B4-BE49-F238E27FC236}">
                <a16:creationId xmlns:a16="http://schemas.microsoft.com/office/drawing/2014/main" xmlns="" id="{99433B9F-20B7-40EF-9D0F-B082E5CF0F91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6">
            <a:extLst>
              <a:ext uri="{FF2B5EF4-FFF2-40B4-BE49-F238E27FC236}">
                <a16:creationId xmlns:a16="http://schemas.microsoft.com/office/drawing/2014/main" xmlns="" id="{3600D71F-D712-4988-8D6B-C3A8465A30C4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E1A33DB-13CC-4D99-8BCC-34AE9FC60BA5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xmlns="" val="21792096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F8CA6-399B-4918-8F4B-292564F58E24}" type="datetimeFigureOut">
              <a:rPr lang="zh-CN" altLang="en-US" smtClean="0"/>
              <a:pPr/>
              <a:t>2018/10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CFC837-AA7B-4BD9-9181-650E0389EF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002488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F8CA6-399B-4918-8F4B-292564F58E24}" type="datetimeFigureOut">
              <a:rPr lang="zh-CN" altLang="en-US" smtClean="0"/>
              <a:pPr/>
              <a:t>2018/10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CFC837-AA7B-4BD9-9181-650E0389EF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31873118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F8CA6-399B-4918-8F4B-292564F58E24}" type="datetimeFigureOut">
              <a:rPr lang="zh-CN" altLang="en-US" smtClean="0"/>
              <a:pPr/>
              <a:t>2018/10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CFC837-AA7B-4BD9-9181-650E0389EF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33992824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F8CA6-399B-4918-8F4B-292564F58E24}" type="datetimeFigureOut">
              <a:rPr lang="zh-CN" altLang="en-US" smtClean="0"/>
              <a:pPr/>
              <a:t>2018/10/2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CFC837-AA7B-4BD9-9181-650E0389EF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4635411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F8CA6-399B-4918-8F4B-292564F58E24}" type="datetimeFigureOut">
              <a:rPr lang="zh-CN" altLang="en-US" smtClean="0"/>
              <a:pPr/>
              <a:t>2018/10/2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CFC837-AA7B-4BD9-9181-650E0389EF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6898477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F8CA6-399B-4918-8F4B-292564F58E24}" type="datetimeFigureOut">
              <a:rPr lang="zh-CN" altLang="en-US" smtClean="0"/>
              <a:pPr/>
              <a:t>2018/10/2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CFC837-AA7B-4BD9-9181-650E0389EF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39943181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F8CA6-399B-4918-8F4B-292564F58E24}" type="datetimeFigureOut">
              <a:rPr lang="zh-CN" altLang="en-US" smtClean="0"/>
              <a:pPr/>
              <a:t>2018/10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CFC837-AA7B-4BD9-9181-650E0389EF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7225272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F8CA6-399B-4918-8F4B-292564F58E24}" type="datetimeFigureOut">
              <a:rPr lang="zh-CN" altLang="en-US" smtClean="0"/>
              <a:pPr/>
              <a:t>2018/10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CFC837-AA7B-4BD9-9181-650E0389EF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31916617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8F8CA6-399B-4918-8F4B-292564F58E24}" type="datetimeFigureOut">
              <a:rPr lang="zh-CN" altLang="en-US" smtClean="0"/>
              <a:pPr/>
              <a:t>2018/10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CFC837-AA7B-4BD9-9181-650E0389EF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4541350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表格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1075471136"/>
              </p:ext>
            </p:extLst>
          </p:nvPr>
        </p:nvGraphicFramePr>
        <p:xfrm>
          <a:off x="884581" y="1381542"/>
          <a:ext cx="10376452" cy="3660732"/>
        </p:xfrm>
        <a:graphic>
          <a:graphicData uri="http://schemas.openxmlformats.org/drawingml/2006/table">
            <a:tbl>
              <a:tblPr/>
              <a:tblGrid>
                <a:gridCol w="1575303">
                  <a:extLst>
                    <a:ext uri="{9D8B030D-6E8A-4147-A177-3AD203B41FA5}">
                      <a16:colId xmlns:a16="http://schemas.microsoft.com/office/drawing/2014/main" xmlns="" val="2980126755"/>
                    </a:ext>
                  </a:extLst>
                </a:gridCol>
                <a:gridCol w="856143">
                  <a:extLst>
                    <a:ext uri="{9D8B030D-6E8A-4147-A177-3AD203B41FA5}">
                      <a16:colId xmlns:a16="http://schemas.microsoft.com/office/drawing/2014/main" xmlns="" val="3608980945"/>
                    </a:ext>
                  </a:extLst>
                </a:gridCol>
                <a:gridCol w="1007495">
                  <a:extLst>
                    <a:ext uri="{9D8B030D-6E8A-4147-A177-3AD203B41FA5}">
                      <a16:colId xmlns:a16="http://schemas.microsoft.com/office/drawing/2014/main" xmlns="" val="717862796"/>
                    </a:ext>
                  </a:extLst>
                </a:gridCol>
                <a:gridCol w="834887">
                  <a:extLst>
                    <a:ext uri="{9D8B030D-6E8A-4147-A177-3AD203B41FA5}">
                      <a16:colId xmlns:a16="http://schemas.microsoft.com/office/drawing/2014/main" xmlns="" val="967488189"/>
                    </a:ext>
                  </a:extLst>
                </a:gridCol>
                <a:gridCol w="1051381">
                  <a:extLst>
                    <a:ext uri="{9D8B030D-6E8A-4147-A177-3AD203B41FA5}">
                      <a16:colId xmlns:a16="http://schemas.microsoft.com/office/drawing/2014/main" xmlns="" val="3994679763"/>
                    </a:ext>
                  </a:extLst>
                </a:gridCol>
                <a:gridCol w="856143">
                  <a:extLst>
                    <a:ext uri="{9D8B030D-6E8A-4147-A177-3AD203B41FA5}">
                      <a16:colId xmlns:a16="http://schemas.microsoft.com/office/drawing/2014/main" xmlns="" val="615504882"/>
                    </a:ext>
                  </a:extLst>
                </a:gridCol>
                <a:gridCol w="4195100">
                  <a:extLst>
                    <a:ext uri="{9D8B030D-6E8A-4147-A177-3AD203B41FA5}">
                      <a16:colId xmlns:a16="http://schemas.microsoft.com/office/drawing/2014/main" xmlns="" val="1834624155"/>
                    </a:ext>
                  </a:extLst>
                </a:gridCol>
              </a:tblGrid>
              <a:tr h="30968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Accession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200" dirty="0" smtClean="0"/>
                        <a:t>WT</a:t>
                      </a:r>
                      <a:endParaRPr lang="zh-CN" altLang="en-US" sz="1200" dirty="0"/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fc17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Log2 ratio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P 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value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FDR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Description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941252306"/>
                  </a:ext>
                </a:extLst>
              </a:tr>
              <a:tr h="32641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LOC_Os02g41630.2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33416.33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88896.93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.66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024464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00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phenylalanine ammonia-lyase, putative, expressed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76444159"/>
                  </a:ext>
                </a:extLst>
              </a:tr>
              <a:tr h="30968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LOC_Os02g08100.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9586.13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4212.0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.53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0177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00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AMP-binding domain containing protein, expressed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582081451"/>
                  </a:ext>
                </a:extLst>
              </a:tr>
              <a:tr h="30968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LOC_Os04g43760.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1134.47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5550.13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.29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039178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00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phenylalanine ammonia-lyase, putative, expressed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229489941"/>
                  </a:ext>
                </a:extLst>
              </a:tr>
              <a:tr h="31177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LOC_Os02g47940.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94.77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550.57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.87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00176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00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aminotransferase, classes I and II, domain containing </a:t>
                      </a: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protein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282563085"/>
                  </a:ext>
                </a:extLst>
              </a:tr>
              <a:tr h="26835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LOC_Os02g19924.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199.23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230.23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.86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001366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00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aminotransferase, classes I and II, domain containing </a:t>
                      </a: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protein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594591284"/>
                  </a:ext>
                </a:extLst>
              </a:tr>
              <a:tr h="30968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LOC_Os05g25640.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671.53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826.83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.69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0146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00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cytochrome P450, putative, expressed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979327325"/>
                  </a:ext>
                </a:extLst>
              </a:tr>
              <a:tr h="27672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LOC_Os01g65090.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819.3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4754.03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.69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012429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00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aminotransferase, classes I and II, domain containing </a:t>
                      </a: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protein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210269752"/>
                  </a:ext>
                </a:extLst>
              </a:tr>
              <a:tr h="30968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LOC_Os06g44620.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884.3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3128.37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.66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016478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00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AMP-binding domain containing protein, expressed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235562026"/>
                  </a:ext>
                </a:extLst>
              </a:tr>
              <a:tr h="30968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LOC_Os02g41650.3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098.8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3410.07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.62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017682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00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phenylalanine ammonia-lyase, putative, expressed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171252000"/>
                  </a:ext>
                </a:extLst>
              </a:tr>
              <a:tr h="30968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LOC_Os06g06980.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809.93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282.47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.58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025924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00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caffeoyl-CoA O-methyltransferase, putative, expressed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978186774"/>
                  </a:ext>
                </a:extLst>
              </a:tr>
              <a:tr h="30968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LOC_Os04g20164.2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77.03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18.03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.53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000336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00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amine oxidase precursor, putative, expressed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130194952"/>
                  </a:ext>
                </a:extLst>
              </a:tr>
            </a:tbl>
          </a:graphicData>
        </a:graphic>
      </p:graphicFrame>
      <p:sp>
        <p:nvSpPr>
          <p:cNvPr id="4" name="矩形 3"/>
          <p:cNvSpPr/>
          <p:nvPr/>
        </p:nvSpPr>
        <p:spPr>
          <a:xfrm>
            <a:off x="823289" y="591884"/>
            <a:ext cx="10499035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kern="0" dirty="0">
                <a:latin typeface="Arial" panose="020B0604020202020204" pitchFamily="34" charset="0"/>
                <a:cs typeface="Arial" panose="020B0604020202020204" pitchFamily="34" charset="0"/>
              </a:rPr>
              <a:t>Additional file </a:t>
            </a:r>
            <a:r>
              <a:rPr lang="en-US" altLang="zh-CN" b="1" kern="0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1.5-fold alterations of proteins involved in phenylalanine metabolism in comparison 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of </a:t>
            </a:r>
            <a:r>
              <a:rPr lang="en-US" altLang="zh-CN" i="1" dirty="0" smtClean="0">
                <a:latin typeface="Arial" panose="020B0604020202020204" pitchFamily="34" charset="0"/>
                <a:cs typeface="Arial" panose="020B0604020202020204" pitchFamily="34" charset="0"/>
              </a:rPr>
              <a:t>fc17 </a:t>
            </a:r>
            <a:r>
              <a:rPr lang="en-US" altLang="zh-CN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TRAQ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data to that of the WT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42109402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735</TotalTime>
  <Words>177</Words>
  <Application>Microsoft Office PowerPoint</Application>
  <PresentationFormat>Custom</PresentationFormat>
  <Paragraphs>8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主题​​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indows 用户</dc:creator>
  <cp:lastModifiedBy>0012761</cp:lastModifiedBy>
  <cp:revision>97</cp:revision>
  <cp:lastPrinted>2018-10-21T01:09:07Z</cp:lastPrinted>
  <dcterms:created xsi:type="dcterms:W3CDTF">2018-01-28T13:46:17Z</dcterms:created>
  <dcterms:modified xsi:type="dcterms:W3CDTF">2018-10-27T12:46:44Z</dcterms:modified>
</cp:coreProperties>
</file>